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  <p:sldId id="258" r:id="rId4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>
      <p:cViewPr varScale="1">
        <p:scale>
          <a:sx n="92" d="100"/>
          <a:sy n="92" d="100"/>
        </p:scale>
        <p:origin x="288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1E95F-78D3-A64D-81AB-800FD54E861E}" type="datetimeFigureOut">
              <a:rPr lang="en-US" smtClean="0"/>
              <a:t>2/2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88C0E-31AB-F540-A0F1-AB334C53E6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37077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1E95F-78D3-A64D-81AB-800FD54E861E}" type="datetimeFigureOut">
              <a:rPr lang="en-US" smtClean="0"/>
              <a:t>2/2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88C0E-31AB-F540-A0F1-AB334C53E6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1270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1E95F-78D3-A64D-81AB-800FD54E861E}" type="datetimeFigureOut">
              <a:rPr lang="en-US" smtClean="0"/>
              <a:t>2/2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88C0E-31AB-F540-A0F1-AB334C53E6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00396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1E95F-78D3-A64D-81AB-800FD54E861E}" type="datetimeFigureOut">
              <a:rPr lang="en-US" smtClean="0"/>
              <a:t>2/2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88C0E-31AB-F540-A0F1-AB334C53E6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86506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1E95F-78D3-A64D-81AB-800FD54E861E}" type="datetimeFigureOut">
              <a:rPr lang="en-US" smtClean="0"/>
              <a:t>2/2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88C0E-31AB-F540-A0F1-AB334C53E6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8482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1E95F-78D3-A64D-81AB-800FD54E861E}" type="datetimeFigureOut">
              <a:rPr lang="en-US" smtClean="0"/>
              <a:t>2/2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88C0E-31AB-F540-A0F1-AB334C53E6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37484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1E95F-78D3-A64D-81AB-800FD54E861E}" type="datetimeFigureOut">
              <a:rPr lang="en-US" smtClean="0"/>
              <a:t>2/29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88C0E-31AB-F540-A0F1-AB334C53E6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40687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1E95F-78D3-A64D-81AB-800FD54E861E}" type="datetimeFigureOut">
              <a:rPr lang="en-US" smtClean="0"/>
              <a:t>2/29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88C0E-31AB-F540-A0F1-AB334C53E6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59232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1E95F-78D3-A64D-81AB-800FD54E861E}" type="datetimeFigureOut">
              <a:rPr lang="en-US" smtClean="0"/>
              <a:t>2/29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88C0E-31AB-F540-A0F1-AB334C53E6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9162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1E95F-78D3-A64D-81AB-800FD54E861E}" type="datetimeFigureOut">
              <a:rPr lang="en-US" smtClean="0"/>
              <a:t>2/2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88C0E-31AB-F540-A0F1-AB334C53E6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92674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1E95F-78D3-A64D-81AB-800FD54E861E}" type="datetimeFigureOut">
              <a:rPr lang="en-US" smtClean="0"/>
              <a:t>2/2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88C0E-31AB-F540-A0F1-AB334C53E6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1171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E1E95F-78D3-A64D-81AB-800FD54E861E}" type="datetimeFigureOut">
              <a:rPr lang="en-US" smtClean="0"/>
              <a:t>2/2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B88C0E-31AB-F540-A0F1-AB334C53E6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1857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FBAD8764-7433-4751-1C22-064AB1934C2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73689" y="1516775"/>
            <a:ext cx="2120698" cy="206369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A19FE12-2073-D5CC-24C8-4F4F8B7EE4D9}"/>
              </a:ext>
            </a:extLst>
          </p:cNvPr>
          <p:cNvSpPr txBox="1"/>
          <p:nvPr/>
        </p:nvSpPr>
        <p:spPr>
          <a:xfrm>
            <a:off x="444863" y="4216615"/>
            <a:ext cx="596827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munoblot detection of indicated proteins in t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 H1975 lung cancer cells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reated with bortezomib for 24 and 48 hours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732025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DAC736F-4D77-B555-D6E1-AE65257DF52D}"/>
              </a:ext>
            </a:extLst>
          </p:cNvPr>
          <p:cNvSpPr txBox="1"/>
          <p:nvPr/>
        </p:nvSpPr>
        <p:spPr>
          <a:xfrm>
            <a:off x="340058" y="6114408"/>
            <a:ext cx="644245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2.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.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isogenic cell line set H1299 stably transfected to express either a p53 null vector control and the mutant p53 R273H were treated with bortezomib for 0, 24 or 48 hours followed by cell lysis and immunoblot for p53.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.)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isogenic cell line set H1299 stably transfected to express either a null vector control, or a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ildtype p53 rescue construct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ere treated with bortezomib for 0, 24 or 48 hours followed by cell lysis and immunoblot for p53. GAPDH is shown as loading control.</a:t>
            </a:r>
            <a:endParaRPr lang="en-US" sz="1200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A8259B8-4572-DD1F-3260-8281917FB0F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555" t="16885" r="62987" b="48242"/>
          <a:stretch/>
        </p:blipFill>
        <p:spPr>
          <a:xfrm>
            <a:off x="1521868" y="955953"/>
            <a:ext cx="3739841" cy="233204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CBA3C58-10FE-B996-1CDE-896CEB01673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7176" t="16884" r="29233" b="49621"/>
          <a:stretch/>
        </p:blipFill>
        <p:spPr>
          <a:xfrm>
            <a:off x="1103950" y="3405980"/>
            <a:ext cx="4157759" cy="233204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1118C82-5D44-B06D-0C0F-7C63524DFBC1}"/>
              </a:ext>
            </a:extLst>
          </p:cNvPr>
          <p:cNvSpPr txBox="1"/>
          <p:nvPr/>
        </p:nvSpPr>
        <p:spPr>
          <a:xfrm>
            <a:off x="1106370" y="1366650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39FBDAD-9096-2309-5487-DB6BE88C53E0}"/>
              </a:ext>
            </a:extLst>
          </p:cNvPr>
          <p:cNvSpPr txBox="1"/>
          <p:nvPr/>
        </p:nvSpPr>
        <p:spPr>
          <a:xfrm>
            <a:off x="1112425" y="3698690"/>
            <a:ext cx="4154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</p:spTree>
    <p:extLst>
      <p:ext uri="{BB962C8B-B14F-4D97-AF65-F5344CB8AC3E}">
        <p14:creationId xmlns:p14="http://schemas.microsoft.com/office/powerpoint/2010/main" val="2621964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ADA0814-0EF5-D24A-90A1-93E6831E35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5081" y="1426747"/>
            <a:ext cx="5981700" cy="33528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0A4704E-998A-10BA-4560-58C38C985AE9}"/>
              </a:ext>
            </a:extLst>
          </p:cNvPr>
          <p:cNvSpPr txBox="1"/>
          <p:nvPr/>
        </p:nvSpPr>
        <p:spPr>
          <a:xfrm>
            <a:off x="494392" y="5163652"/>
            <a:ext cx="613238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3: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isogenic cell line set H1299 stably transfected to express either a null vector control,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ildtype p53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r the mutant p53 R273H were treated with bortezomib for 48 hours followed by Annexin V stain and Flow cytometry. The figure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ows cell distribution by stage of apoptosis and total apoptosis.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** p&lt;0.01, * p&lt;0.05, ns =not significant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87049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64</TotalTime>
  <Words>194</Words>
  <Application>Microsoft Macintosh PowerPoint</Application>
  <PresentationFormat>Letter Paper (8.5x11 in)</PresentationFormat>
  <Paragraphs>5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Dr Eziafa Oduah, M.D., Ph.D.</cp:lastModifiedBy>
  <cp:revision>1</cp:revision>
  <dcterms:created xsi:type="dcterms:W3CDTF">2024-02-29T16:15:43Z</dcterms:created>
  <dcterms:modified xsi:type="dcterms:W3CDTF">2024-02-29T22:32:35Z</dcterms:modified>
</cp:coreProperties>
</file>